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F24F5"/>
    <a:srgbClr val="0319BD"/>
    <a:srgbClr val="3803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1866" y="-48"/>
      </p:cViewPr>
      <p:guideLst>
        <p:guide orient="horz" pos="2880"/>
        <p:guide pos="31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6871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9936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0217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1695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7556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502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3357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750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070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8646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8069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28DF4-9C69-4C7F-8DAF-E86C76B81AF0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5634E-49A5-4E17-ACCB-F00E1C5E80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2474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TextBox 218"/>
          <p:cNvSpPr txBox="1"/>
          <p:nvPr/>
        </p:nvSpPr>
        <p:spPr>
          <a:xfrm>
            <a:off x="253252" y="33993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0" name="그룹 219"/>
          <p:cNvGrpSpPr/>
          <p:nvPr/>
        </p:nvGrpSpPr>
        <p:grpSpPr>
          <a:xfrm>
            <a:off x="764704" y="395536"/>
            <a:ext cx="5688632" cy="8424936"/>
            <a:chOff x="476672" y="323528"/>
            <a:chExt cx="5688632" cy="8424936"/>
          </a:xfrm>
        </p:grpSpPr>
        <p:grpSp>
          <p:nvGrpSpPr>
            <p:cNvPr id="221" name="그룹 220"/>
            <p:cNvGrpSpPr/>
            <p:nvPr/>
          </p:nvGrpSpPr>
          <p:grpSpPr>
            <a:xfrm>
              <a:off x="1285859" y="323528"/>
              <a:ext cx="4879445" cy="8424936"/>
              <a:chOff x="1051963" y="99939"/>
              <a:chExt cx="4879445" cy="8424936"/>
            </a:xfrm>
          </p:grpSpPr>
          <p:grpSp>
            <p:nvGrpSpPr>
              <p:cNvPr id="238" name="그룹 237"/>
              <p:cNvGrpSpPr/>
              <p:nvPr/>
            </p:nvGrpSpPr>
            <p:grpSpPr>
              <a:xfrm>
                <a:off x="1051963" y="99939"/>
                <a:ext cx="4202645" cy="8424936"/>
                <a:chOff x="1051963" y="99939"/>
                <a:chExt cx="4202645" cy="8424936"/>
              </a:xfrm>
            </p:grpSpPr>
            <p:grpSp>
              <p:nvGrpSpPr>
                <p:cNvPr id="242" name="그룹 241"/>
                <p:cNvGrpSpPr/>
                <p:nvPr/>
              </p:nvGrpSpPr>
              <p:grpSpPr>
                <a:xfrm>
                  <a:off x="1051963" y="99939"/>
                  <a:ext cx="4202645" cy="7244289"/>
                  <a:chOff x="1051963" y="387971"/>
                  <a:chExt cx="4202645" cy="7244289"/>
                </a:xfrm>
              </p:grpSpPr>
              <p:pic>
                <p:nvPicPr>
                  <p:cNvPr id="261" name="Picture 7" descr="C:\Users\신광수\Desktop\GPCR\gprA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5993"/>
                  <a:stretch/>
                </p:blipFill>
                <p:spPr bwMode="auto">
                  <a:xfrm>
                    <a:off x="1052736" y="387971"/>
                    <a:ext cx="2916327" cy="57606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2" name="Picture 8" descr="C:\Users\신광수\Desktop\GPCR\gprB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40550"/>
                  <a:stretch/>
                </p:blipFill>
                <p:spPr bwMode="auto">
                  <a:xfrm>
                    <a:off x="1052513" y="964035"/>
                    <a:ext cx="3518673" cy="53505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3" name="Picture 9" descr="C:\Users\신광수\Desktop\GPCR\gprC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8667"/>
                  <a:stretch/>
                </p:blipFill>
                <p:spPr bwMode="auto">
                  <a:xfrm>
                    <a:off x="1052736" y="1540099"/>
                    <a:ext cx="3430684" cy="552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4" name="Picture 10" descr="C:\Users\신광수\Desktop\GPCR\gprD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5993"/>
                  <a:stretch/>
                </p:blipFill>
                <p:spPr bwMode="auto">
                  <a:xfrm>
                    <a:off x="1052736" y="2176686"/>
                    <a:ext cx="3247919" cy="57606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5" name="Picture 11" descr="C:\Users\신광수\Desktop\GPCR\gprF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40095"/>
                  <a:stretch/>
                </p:blipFill>
                <p:spPr bwMode="auto">
                  <a:xfrm>
                    <a:off x="1052736" y="2801152"/>
                    <a:ext cx="3065279" cy="539147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6" name="Picture 12" descr="C:\Users\신광수\Desktop\GPCR\gprG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40005"/>
                  <a:stretch/>
                </p:blipFill>
                <p:spPr bwMode="auto">
                  <a:xfrm>
                    <a:off x="1052513" y="3376403"/>
                    <a:ext cx="3335908" cy="53996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7" name="Picture 13" descr="C:\Users\신광수\Desktop\GPCR\gprH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8884"/>
                  <a:stretch/>
                </p:blipFill>
                <p:spPr bwMode="auto">
                  <a:xfrm>
                    <a:off x="1052513" y="3942382"/>
                    <a:ext cx="2151830" cy="55004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8" name="Picture 14" descr="C:\Users\신광수\Desktop\GPCR\gprI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5993"/>
                  <a:stretch/>
                </p:blipFill>
                <p:spPr bwMode="auto">
                  <a:xfrm>
                    <a:off x="1052513" y="4564435"/>
                    <a:ext cx="2821676" cy="57606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69" name="Picture 15" descr="C:\Users\신광수\Desktop\GPCR\gprJ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5993"/>
                  <a:stretch/>
                </p:blipFill>
                <p:spPr bwMode="auto">
                  <a:xfrm>
                    <a:off x="1052513" y="5140499"/>
                    <a:ext cx="2625461" cy="57606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70" name="Picture 16" descr="C:\Users\신광수\Desktop\GPCR\gprK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38345"/>
                  <a:stretch/>
                </p:blipFill>
                <p:spPr bwMode="auto">
                  <a:xfrm>
                    <a:off x="1052513" y="5593716"/>
                    <a:ext cx="4202095" cy="55489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71" name="Picture 17" descr="C:\Users\신광수\Desktop\GPCR\gprL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40563"/>
                  <a:stretch/>
                </p:blipFill>
                <p:spPr bwMode="auto">
                  <a:xfrm>
                    <a:off x="1052513" y="6156176"/>
                    <a:ext cx="3017891" cy="534931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72" name="Picture 18" descr="C:\Users\신광수\Desktop\GPCR\gprM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60215"/>
                  <a:stretch/>
                </p:blipFill>
                <p:spPr bwMode="auto">
                  <a:xfrm>
                    <a:off x="1051963" y="6660232"/>
                    <a:ext cx="3762151" cy="358063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73" name="Picture 19" descr="C:\Users\신광수\Desktop\GPCR\gprO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40002"/>
                  <a:stretch/>
                </p:blipFill>
                <p:spPr bwMode="auto">
                  <a:xfrm>
                    <a:off x="1051963" y="7092280"/>
                    <a:ext cx="2591648" cy="53998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pic>
              <p:nvPicPr>
                <p:cNvPr id="259" name="Picture 20" descr="C:\Users\신광수\Desktop\GPCR\gprP.png"/>
                <p:cNvPicPr>
                  <a:picLocks noChangeAspect="1" noChangeArrowheads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38968"/>
                <a:stretch/>
              </p:blipFill>
              <p:spPr bwMode="auto">
                <a:xfrm>
                  <a:off x="1051963" y="7380312"/>
                  <a:ext cx="3802751" cy="54928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60" name="Picture 21" descr="C:\Users\신광수\Desktop\GPCR\nopA.png"/>
                <p:cNvPicPr>
                  <a:picLocks noChangeAspect="1" noChangeArrowheads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0845"/>
                <a:stretch/>
              </p:blipFill>
              <p:spPr bwMode="auto">
                <a:xfrm>
                  <a:off x="1052736" y="7992480"/>
                  <a:ext cx="2476508" cy="53239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239" name="그룹 238"/>
              <p:cNvGrpSpPr/>
              <p:nvPr/>
            </p:nvGrpSpPr>
            <p:grpSpPr>
              <a:xfrm>
                <a:off x="5254608" y="8129702"/>
                <a:ext cx="676800" cy="330730"/>
                <a:chOff x="5373216" y="5076056"/>
                <a:chExt cx="676800" cy="330730"/>
              </a:xfrm>
            </p:grpSpPr>
            <p:cxnSp>
              <p:nvCxnSpPr>
                <p:cNvPr id="240" name="직선 연결선 239"/>
                <p:cNvCxnSpPr/>
                <p:nvPr/>
              </p:nvCxnSpPr>
              <p:spPr>
                <a:xfrm>
                  <a:off x="5373216" y="5076056"/>
                  <a:ext cx="6768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1" name="TextBox 240"/>
                <p:cNvSpPr txBox="1"/>
                <p:nvPr/>
              </p:nvSpPr>
              <p:spPr>
                <a:xfrm>
                  <a:off x="5373216" y="5129787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0 aa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22" name="그룹 221"/>
            <p:cNvGrpSpPr/>
            <p:nvPr/>
          </p:nvGrpSpPr>
          <p:grpSpPr>
            <a:xfrm>
              <a:off x="476672" y="413685"/>
              <a:ext cx="800219" cy="8171455"/>
              <a:chOff x="476672" y="413685"/>
              <a:chExt cx="800219" cy="8171455"/>
            </a:xfrm>
          </p:grpSpPr>
          <p:sp>
            <p:nvSpPr>
              <p:cNvPr id="223" name="TextBox 222"/>
              <p:cNvSpPr txBox="1"/>
              <p:nvPr/>
            </p:nvSpPr>
            <p:spPr>
              <a:xfrm>
                <a:off x="476672" y="413685"/>
                <a:ext cx="7661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A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476672" y="995350"/>
                <a:ext cx="77457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B (6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76672" y="6185073"/>
                <a:ext cx="7512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L (6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476672" y="5620720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prK (7)</a:t>
                </a:r>
                <a:endParaRPr lang="ko-KR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476672" y="5166213"/>
                <a:ext cx="7489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J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476672" y="4590149"/>
                <a:ext cx="7152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I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TextBox 228"/>
              <p:cNvSpPr txBox="1"/>
              <p:nvPr/>
            </p:nvSpPr>
            <p:spPr>
              <a:xfrm>
                <a:off x="476672" y="3966961"/>
                <a:ext cx="7825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H (0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476672" y="3407815"/>
                <a:ext cx="7922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G (5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476672" y="2832157"/>
                <a:ext cx="7665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F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476672" y="2214275"/>
                <a:ext cx="7825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D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476672" y="1565656"/>
                <a:ext cx="7825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C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476672" y="6683820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M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476672" y="7123702"/>
                <a:ext cx="7922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O (6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476672" y="7704420"/>
                <a:ext cx="7718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prP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476672" y="8308141"/>
                <a:ext cx="7901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pA (7)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8050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107950" y="251520"/>
            <a:ext cx="6750050" cy="8365554"/>
            <a:chOff x="107950" y="251520"/>
            <a:chExt cx="6750050" cy="8365554"/>
          </a:xfrm>
        </p:grpSpPr>
        <p:grpSp>
          <p:nvGrpSpPr>
            <p:cNvPr id="219" name="그룹 2"/>
            <p:cNvGrpSpPr>
              <a:grpSpLocks/>
            </p:cNvGrpSpPr>
            <p:nvPr/>
          </p:nvGrpSpPr>
          <p:grpSpPr bwMode="auto">
            <a:xfrm>
              <a:off x="107950" y="251520"/>
              <a:ext cx="6750050" cy="2884488"/>
              <a:chOff x="1259433" y="3542527"/>
              <a:chExt cx="6749765" cy="2884997"/>
            </a:xfrm>
          </p:grpSpPr>
          <p:grpSp>
            <p:nvGrpSpPr>
              <p:cNvPr id="220" name="그룹 1"/>
              <p:cNvGrpSpPr>
                <a:grpSpLocks/>
              </p:cNvGrpSpPr>
              <p:nvPr/>
            </p:nvGrpSpPr>
            <p:grpSpPr bwMode="auto">
              <a:xfrm>
                <a:off x="1259433" y="3542527"/>
                <a:ext cx="6749765" cy="2831729"/>
                <a:chOff x="1619672" y="3573016"/>
                <a:chExt cx="6749765" cy="2831729"/>
              </a:xfrm>
            </p:grpSpPr>
            <p:sp>
              <p:nvSpPr>
                <p:cNvPr id="227" name="TextBox 8"/>
                <p:cNvSpPr txBox="1">
                  <a:spLocks noChangeArrowheads="1"/>
                </p:cNvSpPr>
                <p:nvPr/>
              </p:nvSpPr>
              <p:spPr bwMode="auto">
                <a:xfrm>
                  <a:off x="1763688" y="5917698"/>
                  <a:ext cx="40908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9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02</a:t>
                  </a:r>
                  <a:endParaRPr kumimoji="1" lang="ko-KR" altLang="en-US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pic>
              <p:nvPicPr>
                <p:cNvPr id="228" name="Picture 7" descr="C:\Users\신광수\Desktop\그림1.jpg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747" r="30928" b="1833"/>
                <a:stretch>
                  <a:fillRect/>
                </a:stretch>
              </p:blipFill>
              <p:spPr bwMode="auto">
                <a:xfrm>
                  <a:off x="1619672" y="3573016"/>
                  <a:ext cx="6625134" cy="28317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29" name="TextBox 10"/>
                <p:cNvSpPr txBox="1">
                  <a:spLocks noChangeArrowheads="1"/>
                </p:cNvSpPr>
                <p:nvPr/>
              </p:nvSpPr>
              <p:spPr bwMode="auto">
                <a:xfrm>
                  <a:off x="5822663" y="3729587"/>
                  <a:ext cx="90120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b="1" smtClean="0">
                      <a:solidFill>
                        <a:srgbClr val="FF0000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fu4g01350</a:t>
                  </a:r>
                  <a:endParaRPr kumimoji="1" lang="ko-KR" altLang="en-US" sz="1000" b="1" smtClean="0">
                    <a:solidFill>
                      <a:srgbClr val="FF0000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0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5881831" y="4396163"/>
                  <a:ext cx="97654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CLA 067510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1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6922119" y="4660140"/>
                  <a:ext cx="9845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NID 07795.1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2" name="TextBox 13"/>
                <p:cNvSpPr txBox="1">
                  <a:spLocks noChangeArrowheads="1"/>
                </p:cNvSpPr>
                <p:nvPr/>
              </p:nvSpPr>
              <p:spPr bwMode="auto">
                <a:xfrm>
                  <a:off x="6265643" y="4922547"/>
                  <a:ext cx="1026243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TEG 08180.1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3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5700246" y="5204280"/>
                  <a:ext cx="1215397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O090103000244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4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5726880" y="5459379"/>
                  <a:ext cx="1082348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FL2G 12145.2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5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6915193" y="5723356"/>
                  <a:ext cx="1454244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ASPNIDRAFT 131536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236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5682490" y="4128208"/>
                  <a:ext cx="934871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2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20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6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ts val="300"/>
                    </a:spcAft>
                    <a:buClr>
                      <a:srgbClr val="D14224"/>
                    </a:buClr>
                    <a:buSzPct val="130000"/>
                    <a:buFont typeface="Georgia" pitchFamily="18" charset="0"/>
                    <a:buChar char="*"/>
                    <a:defRPr sz="1400">
                      <a:solidFill>
                        <a:srgbClr val="404040"/>
                      </a:solidFill>
                      <a:latin typeface="Trebuchet MS" pitchFamily="34" charset="0"/>
                      <a:ea typeface="HY그래픽M" pitchFamily="18" charset="-127"/>
                    </a:defRPr>
                  </a:lvl9pPr>
                </a:lstStyle>
                <a:p>
                  <a:pPr eaLnBrk="1" fontAlgn="base" hangingPunct="1"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1" lang="en-US" altLang="ko-KR" sz="1000" smtClean="0">
                      <a:solidFill>
                        <a:prstClr val="black"/>
                      </a:solidFill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NFIA 043940</a:t>
                  </a:r>
                  <a:endParaRPr kumimoji="1" lang="ko-KR" altLang="en-US" sz="10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</p:grpSp>
          <p:sp>
            <p:nvSpPr>
              <p:cNvPr id="221" name="TextBox 19"/>
              <p:cNvSpPr txBox="1">
                <a:spLocks noChangeArrowheads="1"/>
              </p:cNvSpPr>
              <p:nvPr/>
            </p:nvSpPr>
            <p:spPr bwMode="auto">
              <a:xfrm>
                <a:off x="2209737" y="6196692"/>
                <a:ext cx="4090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2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0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6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9pPr>
              </a:lstStyle>
              <a:p>
                <a:pPr eaLnBrk="1" fontAlgn="base" hangingPunct="1"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1" lang="en-US" altLang="ko-KR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0.05</a:t>
                </a:r>
                <a:endParaRPr kumimoji="1" lang="ko-KR" altLang="en-US" sz="900" smtClean="0">
                  <a:solidFill>
                    <a:prstClr val="black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222" name="TextBox 21"/>
              <p:cNvSpPr txBox="1">
                <a:spLocks noChangeArrowheads="1"/>
              </p:cNvSpPr>
              <p:nvPr/>
            </p:nvSpPr>
            <p:spPr bwMode="auto">
              <a:xfrm>
                <a:off x="2086659" y="4873118"/>
                <a:ext cx="31290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2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0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6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9pPr>
              </a:lstStyle>
              <a:p>
                <a:pPr eaLnBrk="1" fontAlgn="base" hangingPunct="1"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1" lang="en-US" altLang="ko-KR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57</a:t>
                </a:r>
                <a:endParaRPr kumimoji="1" lang="ko-KR" altLang="en-US" sz="900" smtClean="0">
                  <a:solidFill>
                    <a:prstClr val="black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223" name="TextBox 22"/>
              <p:cNvSpPr txBox="1">
                <a:spLocks noChangeArrowheads="1"/>
              </p:cNvSpPr>
              <p:nvPr/>
            </p:nvSpPr>
            <p:spPr bwMode="auto">
              <a:xfrm>
                <a:off x="1832344" y="4365674"/>
                <a:ext cx="31290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2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0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6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9pPr>
              </a:lstStyle>
              <a:p>
                <a:pPr eaLnBrk="1" fontAlgn="base" hangingPunct="1"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1" lang="en-US" altLang="ko-KR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36</a:t>
                </a:r>
                <a:endParaRPr kumimoji="1" lang="ko-KR" altLang="en-US" sz="900" smtClean="0">
                  <a:solidFill>
                    <a:prstClr val="black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224" name="TextBox 23"/>
              <p:cNvSpPr txBox="1">
                <a:spLocks noChangeArrowheads="1"/>
              </p:cNvSpPr>
              <p:nvPr/>
            </p:nvSpPr>
            <p:spPr bwMode="auto">
              <a:xfrm>
                <a:off x="3608278" y="4056078"/>
                <a:ext cx="3770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2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0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6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9pPr>
              </a:lstStyle>
              <a:p>
                <a:pPr eaLnBrk="1" fontAlgn="base" hangingPunct="1"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1" lang="en-US" altLang="ko-KR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00</a:t>
                </a:r>
                <a:endParaRPr kumimoji="1" lang="ko-KR" altLang="en-US" sz="900" smtClean="0">
                  <a:solidFill>
                    <a:prstClr val="black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225" name="TextBox 24"/>
              <p:cNvSpPr txBox="1">
                <a:spLocks noChangeArrowheads="1"/>
              </p:cNvSpPr>
              <p:nvPr/>
            </p:nvSpPr>
            <p:spPr bwMode="auto">
              <a:xfrm>
                <a:off x="4872126" y="3814896"/>
                <a:ext cx="3770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2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0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6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9pPr>
              </a:lstStyle>
              <a:p>
                <a:pPr eaLnBrk="1" fontAlgn="base" hangingPunct="1"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1" lang="en-US" altLang="ko-KR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00</a:t>
                </a:r>
                <a:endParaRPr kumimoji="1" lang="ko-KR" altLang="en-US" sz="900" smtClean="0">
                  <a:solidFill>
                    <a:prstClr val="black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226" name="TextBox 25"/>
              <p:cNvSpPr txBox="1">
                <a:spLocks noChangeArrowheads="1"/>
              </p:cNvSpPr>
              <p:nvPr/>
            </p:nvSpPr>
            <p:spPr bwMode="auto">
              <a:xfrm>
                <a:off x="5034005" y="5420012"/>
                <a:ext cx="3770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2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20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6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ts val="300"/>
                  </a:spcAft>
                  <a:buClr>
                    <a:srgbClr val="D14224"/>
                  </a:buClr>
                  <a:buSzPct val="130000"/>
                  <a:buFont typeface="Georgia" pitchFamily="18" charset="0"/>
                  <a:buChar char="*"/>
                  <a:defRPr sz="1400">
                    <a:solidFill>
                      <a:srgbClr val="404040"/>
                    </a:solidFill>
                    <a:latin typeface="Trebuchet MS" pitchFamily="34" charset="0"/>
                    <a:ea typeface="HY그래픽M" pitchFamily="18" charset="-127"/>
                  </a:defRPr>
                </a:lvl9pPr>
              </a:lstStyle>
              <a:p>
                <a:pPr eaLnBrk="1" fontAlgn="base" hangingPunct="1"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1" lang="en-US" altLang="ko-KR" sz="900" smtClean="0">
                    <a:solidFill>
                      <a:prstClr val="black"/>
                    </a:solidFill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00</a:t>
                </a:r>
                <a:endParaRPr kumimoji="1" lang="ko-KR" altLang="en-US" sz="900" smtClean="0">
                  <a:solidFill>
                    <a:prstClr val="black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</p:grpSp>
        <p:sp>
          <p:nvSpPr>
            <p:cNvPr id="237" name="TextBox 236"/>
            <p:cNvSpPr txBox="1"/>
            <p:nvPr/>
          </p:nvSpPr>
          <p:spPr>
            <a:xfrm>
              <a:off x="242487" y="323528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36877" y="330353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4354" y="3595673"/>
              <a:ext cx="4967713" cy="50214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749696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86</Words>
  <Application>Microsoft Office PowerPoint</Application>
  <PresentationFormat>화면 슬라이드 쇼(4:3)</PresentationFormat>
  <Paragraphs>34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신광수</dc:creator>
  <cp:lastModifiedBy>신광수</cp:lastModifiedBy>
  <cp:revision>19</cp:revision>
  <dcterms:created xsi:type="dcterms:W3CDTF">2016-04-05T03:36:12Z</dcterms:created>
  <dcterms:modified xsi:type="dcterms:W3CDTF">2016-07-10T23:08:41Z</dcterms:modified>
</cp:coreProperties>
</file>